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70" r:id="rId2"/>
    <p:sldId id="268" r:id="rId3"/>
    <p:sldId id="269" r:id="rId4"/>
  </p:sldIdLst>
  <p:sldSz cx="6858000" cy="9906000" type="A4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10F81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202" autoAdjust="0"/>
    <p:restoredTop sz="93404" autoAdjust="0"/>
  </p:normalViewPr>
  <p:slideViewPr>
    <p:cSldViewPr snapToGrid="0">
      <p:cViewPr varScale="1">
        <p:scale>
          <a:sx n="74" d="100"/>
          <a:sy n="74" d="100"/>
        </p:scale>
        <p:origin x="306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06C742-90B9-45BD-ADCA-37E7E3DC6E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58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73575"/>
            <a:ext cx="55054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754B1C-3781-4C19-A849-EC9029D16A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67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494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177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937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428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488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288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099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398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489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810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255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528AFB-0330-414F-914C-FEC49ACA1FFF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D81E81-4ED0-4F18-AFCB-575CB2DAB1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143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7" Type="http://schemas.openxmlformats.org/officeDocument/2006/relationships/image" Target="../media/image1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0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">
            <a:extLst>
              <a:ext uri="{FF2B5EF4-FFF2-40B4-BE49-F238E27FC236}">
                <a16:creationId xmlns:a16="http://schemas.microsoft.com/office/drawing/2014/main" id="{78F592F3-9C22-0B40-08BD-F1489C3B87D4}"/>
              </a:ext>
            </a:extLst>
          </p:cNvPr>
          <p:cNvSpPr txBox="1"/>
          <p:nvPr/>
        </p:nvSpPr>
        <p:spPr>
          <a:xfrm>
            <a:off x="109946" y="4475480"/>
            <a:ext cx="6705600" cy="6756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Confirmation of </a:t>
            </a:r>
            <a:r>
              <a:rPr lang="en-US" sz="12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phs1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nockout upon IF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fluorescence staining was performed using anti-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phrin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ti-WT1, and DAPI labeling for nuclei on kidney tissue from 1-day old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phs1</a:t>
            </a:r>
            <a:r>
              <a:rPr lang="en-US" sz="1200" i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-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ol (a) and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phs1</a:t>
            </a:r>
            <a:r>
              <a:rPr lang="en-US" sz="1200" i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(b). Images shown are representative examples obtained via confocal laser scanning microscopy. Scale bar, 20 µm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BD8D3AC-EFC5-92BA-8509-2B65901D69CF}"/>
              </a:ext>
            </a:extLst>
          </p:cNvPr>
          <p:cNvGrpSpPr/>
          <p:nvPr/>
        </p:nvGrpSpPr>
        <p:grpSpPr>
          <a:xfrm>
            <a:off x="224854" y="667830"/>
            <a:ext cx="6190805" cy="2910881"/>
            <a:chOff x="224854" y="667830"/>
            <a:chExt cx="6190805" cy="2910881"/>
          </a:xfrm>
        </p:grpSpPr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9CE19DF6-2AEA-EB71-8DC4-1B6C1A758C17}"/>
                </a:ext>
              </a:extLst>
            </p:cNvPr>
            <p:cNvGrpSpPr/>
            <p:nvPr/>
          </p:nvGrpSpPr>
          <p:grpSpPr>
            <a:xfrm>
              <a:off x="224854" y="667830"/>
              <a:ext cx="6190805" cy="2910881"/>
              <a:chOff x="224854" y="667830"/>
              <a:chExt cx="6190805" cy="2910881"/>
            </a:xfrm>
          </p:grpSpPr>
          <p:pic>
            <p:nvPicPr>
              <p:cNvPr id="20" name="Picture 19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B252CE14-188C-56C5-4E63-6CA4C3BCD1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46215" y="691242"/>
                <a:ext cx="1386840" cy="1386840"/>
              </a:xfrm>
              <a:prstGeom prst="rect">
                <a:avLst/>
              </a:prstGeom>
            </p:spPr>
          </p:pic>
          <p:pic>
            <p:nvPicPr>
              <p:cNvPr id="22" name="Picture 21" descr="A close-up of a black background&#10;&#10;Description automatically generated">
                <a:extLst>
                  <a:ext uri="{FF2B5EF4-FFF2-40B4-BE49-F238E27FC236}">
                    <a16:creationId xmlns:a16="http://schemas.microsoft.com/office/drawing/2014/main" id="{50600819-429E-9BF9-C7E6-E1CDE0782E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07326" y="691242"/>
                <a:ext cx="1386840" cy="1386840"/>
              </a:xfrm>
              <a:prstGeom prst="rect">
                <a:avLst/>
              </a:prstGeom>
            </p:spPr>
          </p:pic>
          <p:pic>
            <p:nvPicPr>
              <p:cNvPr id="24" name="Picture 23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714ACFC1-359D-C581-2478-762D190FE9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1906" y="691242"/>
                <a:ext cx="1386840" cy="1386840"/>
              </a:xfrm>
              <a:prstGeom prst="rect">
                <a:avLst/>
              </a:prstGeom>
            </p:spPr>
          </p:pic>
          <p:pic>
            <p:nvPicPr>
              <p:cNvPr id="26" name="Picture 25" descr="A close-up of a dog paw print&#10;&#10;Description automatically generated">
                <a:extLst>
                  <a:ext uri="{FF2B5EF4-FFF2-40B4-BE49-F238E27FC236}">
                    <a16:creationId xmlns:a16="http://schemas.microsoft.com/office/drawing/2014/main" id="{0F136871-6054-B4B5-DD87-1470A04193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62746" y="691242"/>
                <a:ext cx="1386840" cy="1386840"/>
              </a:xfrm>
              <a:prstGeom prst="rect">
                <a:avLst/>
              </a:prstGeom>
            </p:spPr>
          </p:pic>
          <p:pic>
            <p:nvPicPr>
              <p:cNvPr id="28" name="Picture 27" descr="A close-up of a blue and black background&#10;&#10;Description automatically generated">
                <a:extLst>
                  <a:ext uri="{FF2B5EF4-FFF2-40B4-BE49-F238E27FC236}">
                    <a16:creationId xmlns:a16="http://schemas.microsoft.com/office/drawing/2014/main" id="{F73AFE67-B633-464E-BE8E-FBC2D33BD1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46215" y="2191871"/>
                <a:ext cx="1386840" cy="1386840"/>
              </a:xfrm>
              <a:prstGeom prst="rect">
                <a:avLst/>
              </a:prstGeom>
            </p:spPr>
          </p:pic>
          <p:pic>
            <p:nvPicPr>
              <p:cNvPr id="30" name="Picture 29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97716910-C1E4-BE57-BF70-E54C1E4343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1906" y="2191870"/>
                <a:ext cx="1386840" cy="1386840"/>
              </a:xfrm>
              <a:prstGeom prst="rect">
                <a:avLst/>
              </a:prstGeom>
            </p:spPr>
          </p:pic>
          <p:pic>
            <p:nvPicPr>
              <p:cNvPr id="32" name="Picture 31" descr="A black and white background&#10;&#10;Description automatically generated">
                <a:extLst>
                  <a:ext uri="{FF2B5EF4-FFF2-40B4-BE49-F238E27FC236}">
                    <a16:creationId xmlns:a16="http://schemas.microsoft.com/office/drawing/2014/main" id="{6CFBDCCD-9C7F-FE6C-75A0-1F8464D12A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76770" y="2191870"/>
                <a:ext cx="1386840" cy="1386840"/>
              </a:xfrm>
              <a:prstGeom prst="rect">
                <a:avLst/>
              </a:prstGeom>
            </p:spPr>
          </p:pic>
          <p:pic>
            <p:nvPicPr>
              <p:cNvPr id="34" name="Picture 33" descr="A black background with white circles&#10;&#10;Description automatically generated">
                <a:extLst>
                  <a:ext uri="{FF2B5EF4-FFF2-40B4-BE49-F238E27FC236}">
                    <a16:creationId xmlns:a16="http://schemas.microsoft.com/office/drawing/2014/main" id="{1B6F15D6-F560-DFC8-22F1-A3E086F11D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07326" y="2191870"/>
                <a:ext cx="1386840" cy="1386840"/>
              </a:xfrm>
              <a:prstGeom prst="rect">
                <a:avLst/>
              </a:prstGeom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A518419-5AF4-D37B-0780-E5ED9CE97A27}"/>
                  </a:ext>
                </a:extLst>
              </p:cNvPr>
              <p:cNvSpPr txBox="1"/>
              <p:nvPr/>
            </p:nvSpPr>
            <p:spPr>
              <a:xfrm>
                <a:off x="224854" y="676449"/>
                <a:ext cx="2857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D09B4ED-D10A-A193-1C46-42D83894AE8F}"/>
                  </a:ext>
                </a:extLst>
              </p:cNvPr>
              <p:cNvSpPr txBox="1"/>
              <p:nvPr/>
            </p:nvSpPr>
            <p:spPr>
              <a:xfrm>
                <a:off x="224854" y="2168458"/>
                <a:ext cx="2857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BE12EF94-9651-2A3F-4002-5B1D2C3FAE3F}"/>
                  </a:ext>
                </a:extLst>
              </p:cNvPr>
              <p:cNvSpPr txBox="1"/>
              <p:nvPr/>
            </p:nvSpPr>
            <p:spPr>
              <a:xfrm>
                <a:off x="521372" y="2191870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0070C0"/>
                    </a:solidFill>
                    <a:highlight>
                      <a:srgbClr val="C0C0C0"/>
                    </a:highlight>
                  </a:rPr>
                  <a:t>DAPI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A6EC9D9-F9B0-4516-CB61-FB9A9121A340}"/>
                  </a:ext>
                </a:extLst>
              </p:cNvPr>
              <p:cNvSpPr txBox="1"/>
              <p:nvPr/>
            </p:nvSpPr>
            <p:spPr>
              <a:xfrm>
                <a:off x="4918166" y="698477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0070C0"/>
                    </a:solidFill>
                  </a:rPr>
                  <a:t>DAPI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543E2D82-A5FB-6A93-5EA8-91D38FC3DF29}"/>
                  </a:ext>
                </a:extLst>
              </p:cNvPr>
              <p:cNvSpPr txBox="1"/>
              <p:nvPr/>
            </p:nvSpPr>
            <p:spPr>
              <a:xfrm>
                <a:off x="2021350" y="2183251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WT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E9B956D2-0756-3DFD-A21B-EBE2F53A0943}"/>
                  </a:ext>
                </a:extLst>
              </p:cNvPr>
              <p:cNvSpPr txBox="1"/>
              <p:nvPr/>
            </p:nvSpPr>
            <p:spPr>
              <a:xfrm>
                <a:off x="5284652" y="696588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WT1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A80FDC2-817B-DAC7-6501-0F27A99835C6}"/>
                  </a:ext>
                </a:extLst>
              </p:cNvPr>
              <p:cNvSpPr txBox="1"/>
              <p:nvPr/>
            </p:nvSpPr>
            <p:spPr>
              <a:xfrm>
                <a:off x="3462426" y="2183251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00FF"/>
                    </a:solidFill>
                  </a:rPr>
                  <a:t>Nphs1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BF5BE947-C0CE-F948-9744-C1A20CFA423F}"/>
                  </a:ext>
                </a:extLst>
              </p:cNvPr>
              <p:cNvSpPr txBox="1"/>
              <p:nvPr/>
            </p:nvSpPr>
            <p:spPr>
              <a:xfrm>
                <a:off x="5639635" y="696588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00FF"/>
                    </a:solidFill>
                  </a:rPr>
                  <a:t>Nphs1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7A75FE99-E065-93F9-4389-C9A0966C65C7}"/>
                  </a:ext>
                </a:extLst>
              </p:cNvPr>
              <p:cNvSpPr txBox="1"/>
              <p:nvPr/>
            </p:nvSpPr>
            <p:spPr>
              <a:xfrm>
                <a:off x="4946214" y="3301198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</a:rPr>
                  <a:t>Merge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C9F21108-5AC1-F95C-7A95-FF860A2F7024}"/>
                  </a:ext>
                </a:extLst>
              </p:cNvPr>
              <p:cNvSpPr txBox="1"/>
              <p:nvPr/>
            </p:nvSpPr>
            <p:spPr>
              <a:xfrm>
                <a:off x="4947049" y="1816472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</a:rPr>
                  <a:t>Merge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2E226B35-64E2-F179-DC39-CE10E10B2885}"/>
                  </a:ext>
                </a:extLst>
              </p:cNvPr>
              <p:cNvSpPr txBox="1"/>
              <p:nvPr/>
            </p:nvSpPr>
            <p:spPr>
              <a:xfrm>
                <a:off x="4937996" y="2181314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0070C0"/>
                    </a:solidFill>
                  </a:rPr>
                  <a:t>DAPI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220C5E7E-B394-A395-1819-C5BDDBD6E6ED}"/>
                  </a:ext>
                </a:extLst>
              </p:cNvPr>
              <p:cNvSpPr txBox="1"/>
              <p:nvPr/>
            </p:nvSpPr>
            <p:spPr>
              <a:xfrm>
                <a:off x="5304482" y="2179425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WT1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FA96FE16-5410-B009-4545-41905B08B9A2}"/>
                  </a:ext>
                </a:extLst>
              </p:cNvPr>
              <p:cNvSpPr txBox="1"/>
              <p:nvPr/>
            </p:nvSpPr>
            <p:spPr>
              <a:xfrm>
                <a:off x="5659465" y="2179425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00FF"/>
                    </a:solidFill>
                  </a:rPr>
                  <a:t>Nphs1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52B7CD4D-981A-874E-C1DC-F1AB216B73A1}"/>
                  </a:ext>
                </a:extLst>
              </p:cNvPr>
              <p:cNvSpPr txBox="1"/>
              <p:nvPr/>
            </p:nvSpPr>
            <p:spPr>
              <a:xfrm>
                <a:off x="521372" y="676449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0070C0"/>
                    </a:solidFill>
                    <a:highlight>
                      <a:srgbClr val="C0C0C0"/>
                    </a:highlight>
                  </a:rPr>
                  <a:t>DAPI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3A95B82F-707B-6762-5A93-B34F87D9A874}"/>
                  </a:ext>
                </a:extLst>
              </p:cNvPr>
              <p:cNvSpPr txBox="1"/>
              <p:nvPr/>
            </p:nvSpPr>
            <p:spPr>
              <a:xfrm>
                <a:off x="2021350" y="667830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FF00"/>
                    </a:solidFill>
                  </a:rPr>
                  <a:t>WT1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00B9FE2C-9FE7-36C2-D4A6-74F4F7F18427}"/>
                  </a:ext>
                </a:extLst>
              </p:cNvPr>
              <p:cNvSpPr txBox="1"/>
              <p:nvPr/>
            </p:nvSpPr>
            <p:spPr>
              <a:xfrm>
                <a:off x="3462426" y="667830"/>
                <a:ext cx="75619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00FF"/>
                    </a:solidFill>
                  </a:rPr>
                  <a:t>Nphs1</a:t>
                </a:r>
              </a:p>
            </p:txBody>
          </p:sp>
        </p:grp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198FF819-A84B-AF7B-3388-F08A30E24781}"/>
                </a:ext>
              </a:extLst>
            </p:cNvPr>
            <p:cNvSpPr/>
            <p:nvPr/>
          </p:nvSpPr>
          <p:spPr>
            <a:xfrm>
              <a:off x="3190069" y="1997122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016E5F8C-429A-2F6A-0990-ADE51DCF5C09}"/>
                </a:ext>
              </a:extLst>
            </p:cNvPr>
            <p:cNvSpPr/>
            <p:nvPr/>
          </p:nvSpPr>
          <p:spPr>
            <a:xfrm>
              <a:off x="1727272" y="1995322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DDAFA530-980B-E45B-F153-FF6B324B46F9}"/>
                </a:ext>
              </a:extLst>
            </p:cNvPr>
            <p:cNvSpPr/>
            <p:nvPr/>
          </p:nvSpPr>
          <p:spPr>
            <a:xfrm>
              <a:off x="1736082" y="3503927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659150C6-48CB-1A8E-6408-98CCD5508EEF}"/>
                </a:ext>
              </a:extLst>
            </p:cNvPr>
            <p:cNvSpPr/>
            <p:nvPr/>
          </p:nvSpPr>
          <p:spPr>
            <a:xfrm>
              <a:off x="3190069" y="3503926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65DCABC-279D-EA4F-7AF4-7C6DA85DD7A5}"/>
                </a:ext>
              </a:extLst>
            </p:cNvPr>
            <p:cNvSpPr/>
            <p:nvPr/>
          </p:nvSpPr>
          <p:spPr>
            <a:xfrm>
              <a:off x="4654538" y="3501546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6E6934A-E6AF-0BC0-6A21-B7B5B58FCB28}"/>
                </a:ext>
              </a:extLst>
            </p:cNvPr>
            <p:cNvSpPr/>
            <p:nvPr/>
          </p:nvSpPr>
          <p:spPr>
            <a:xfrm>
              <a:off x="4649776" y="1997703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C4B7CB67-58DF-8676-45A8-59F2663A9FE7}"/>
                </a:ext>
              </a:extLst>
            </p:cNvPr>
            <p:cNvSpPr/>
            <p:nvPr/>
          </p:nvSpPr>
          <p:spPr>
            <a:xfrm>
              <a:off x="6130046" y="1997703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D8618CA6-6E5F-A76C-8D84-3356DAF2BF69}"/>
                </a:ext>
              </a:extLst>
            </p:cNvPr>
            <p:cNvSpPr/>
            <p:nvPr/>
          </p:nvSpPr>
          <p:spPr>
            <a:xfrm>
              <a:off x="6130046" y="3501546"/>
              <a:ext cx="17604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526207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33F1DE5-B0D5-D6B7-5B6C-137E8E0EE486}"/>
              </a:ext>
            </a:extLst>
          </p:cNvPr>
          <p:cNvSpPr txBox="1"/>
          <p:nvPr/>
        </p:nvSpPr>
        <p:spPr>
          <a:xfrm>
            <a:off x="352697" y="4646923"/>
            <a:ext cx="608691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lomerular cysts and number of mature glomeruli on light microscopy, and evaluation of GBM width upo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n TEM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t P0-P1, k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idney images (PAS stained for a, b; electron micrographs for c) of 10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hs1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/-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ontrol and 10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hs1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ice were analyzed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Appropriate kidney sections for light microscopy evaluation were identified as described in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Figure 3 a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and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 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. GBM width was measured upon TEM within perpendicularly sectioned stretches of GBM as defined in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Figure 2 a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and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hs1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mice had </a:t>
            </a:r>
            <a:r>
              <a:rPr lang="en-US" sz="1200" b="0" i="0" u="none" strike="noStrike" dirty="0">
                <a:effectLst/>
                <a:latin typeface="arial" panose="020B0604020202020204" pitchFamily="34" charset="0"/>
              </a:rPr>
              <a:t>~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12 glomerular cysts per section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hs1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/-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controls had </a:t>
            </a:r>
            <a:r>
              <a:rPr lang="en-US" sz="1200" b="0" i="0" u="none" strike="noStrike" dirty="0">
                <a:effectLst/>
                <a:latin typeface="arial" panose="020B0604020202020204" pitchFamily="34" charset="0"/>
              </a:rPr>
              <a:t>~1 glomerular cyst per section. Two-tailed Mann-Whitney test P &lt; 0.0001 (</a:t>
            </a:r>
            <a:r>
              <a:rPr lang="en-US" sz="1200" b="1" i="0" u="none" strike="noStrike" dirty="0">
                <a:effectLst/>
                <a:latin typeface="arial" panose="020B0604020202020204" pitchFamily="34" charset="0"/>
              </a:rPr>
              <a:t>a</a:t>
            </a:r>
            <a:r>
              <a:rPr lang="en-US" sz="1200" b="0" i="0" u="none" strike="noStrike" dirty="0">
                <a:effectLst/>
                <a:latin typeface="arial" panose="020B0604020202020204" pitchFamily="34" charset="0"/>
              </a:rPr>
              <a:t>). The number of mature glomeruli (</a:t>
            </a:r>
            <a:r>
              <a:rPr lang="en-US" sz="1200" b="1" dirty="0">
                <a:latin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</a:rPr>
              <a:t>) </a:t>
            </a:r>
            <a:r>
              <a:rPr lang="en-US" sz="1200" b="0" i="0" u="none" strike="noStrike" dirty="0">
                <a:effectLst/>
                <a:latin typeface="arial" panose="020B0604020202020204" pitchFamily="34" charset="0"/>
              </a:rPr>
              <a:t>and GBM width (</a:t>
            </a:r>
            <a:r>
              <a:rPr lang="en-US" sz="1200" b="1" i="0" u="none" strike="noStrike" dirty="0">
                <a:effectLst/>
                <a:latin typeface="arial" panose="020B0604020202020204" pitchFamily="34" charset="0"/>
              </a:rPr>
              <a:t>c</a:t>
            </a:r>
            <a:r>
              <a:rPr lang="en-US" sz="1200" b="0" i="0" u="none" strike="noStrike" dirty="0">
                <a:effectLst/>
                <a:latin typeface="arial" panose="020B0604020202020204" pitchFamily="34" charset="0"/>
              </a:rPr>
              <a:t>) did not differ between groups. </a:t>
            </a:r>
            <a:endParaRPr lang="en-US" sz="1200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05B4C4C-9887-EC93-9F4A-E7558B42CC8D}"/>
              </a:ext>
            </a:extLst>
          </p:cNvPr>
          <p:cNvGrpSpPr/>
          <p:nvPr/>
        </p:nvGrpSpPr>
        <p:grpSpPr>
          <a:xfrm>
            <a:off x="257175" y="1272602"/>
            <a:ext cx="6136165" cy="3321779"/>
            <a:chOff x="257175" y="1272602"/>
            <a:chExt cx="6136165" cy="3321779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6973FC8B-9769-6285-B523-2FCE48B0131A}"/>
                </a:ext>
              </a:extLst>
            </p:cNvPr>
            <p:cNvGrpSpPr/>
            <p:nvPr/>
          </p:nvGrpSpPr>
          <p:grpSpPr>
            <a:xfrm>
              <a:off x="257175" y="1272602"/>
              <a:ext cx="4617278" cy="3269489"/>
              <a:chOff x="257175" y="1272602"/>
              <a:chExt cx="4617278" cy="3269489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F3D2FA6D-57C4-B631-CE3B-FF9C261880A2}"/>
                  </a:ext>
                </a:extLst>
              </p:cNvPr>
              <p:cNvGrpSpPr/>
              <p:nvPr/>
            </p:nvGrpSpPr>
            <p:grpSpPr>
              <a:xfrm>
                <a:off x="308711" y="1288379"/>
                <a:ext cx="4565742" cy="355538"/>
                <a:chOff x="308711" y="1288379"/>
                <a:chExt cx="4565742" cy="355538"/>
              </a:xfrm>
            </p:grpSpPr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02DBB851-427D-24F8-09CB-835BD09BB5AA}"/>
                    </a:ext>
                  </a:extLst>
                </p:cNvPr>
                <p:cNvSpPr txBox="1"/>
                <p:nvPr/>
              </p:nvSpPr>
              <p:spPr>
                <a:xfrm>
                  <a:off x="308711" y="1295838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67D5E002-ABB3-D41A-E8C0-5928147EAB54}"/>
                    </a:ext>
                  </a:extLst>
                </p:cNvPr>
                <p:cNvSpPr txBox="1"/>
                <p:nvPr/>
              </p:nvSpPr>
              <p:spPr>
                <a:xfrm>
                  <a:off x="2446319" y="1305363"/>
                  <a:ext cx="30970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E9A14592-79FE-0653-068A-72B16EB8A0FD}"/>
                    </a:ext>
                  </a:extLst>
                </p:cNvPr>
                <p:cNvSpPr txBox="1"/>
                <p:nvPr/>
              </p:nvSpPr>
              <p:spPr>
                <a:xfrm>
                  <a:off x="4575973" y="1288379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</p:grpSp>
          <p:graphicFrame>
            <p:nvGraphicFramePr>
              <p:cNvPr id="5" name="Object 4">
                <a:extLst>
                  <a:ext uri="{FF2B5EF4-FFF2-40B4-BE49-F238E27FC236}">
                    <a16:creationId xmlns:a16="http://schemas.microsoft.com/office/drawing/2014/main" id="{69CE73D2-3AC0-B0A3-6A00-3ABAD29EA51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72732927"/>
                  </p:ext>
                </p:extLst>
              </p:nvPr>
            </p:nvGraphicFramePr>
            <p:xfrm>
              <a:off x="2358057" y="1272602"/>
              <a:ext cx="2093297" cy="326948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2" imgW="2258051" imgH="3526628" progId="Prism10.Document">
                      <p:embed/>
                    </p:oleObj>
                  </mc:Choice>
                  <mc:Fallback>
                    <p:oleObj name="Prism 10" r:id="rId2" imgW="2258051" imgH="3526628" progId="Prism10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2358057" y="1272602"/>
                            <a:ext cx="2093297" cy="326948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>
                <a:extLst>
                  <a:ext uri="{FF2B5EF4-FFF2-40B4-BE49-F238E27FC236}">
                    <a16:creationId xmlns:a16="http://schemas.microsoft.com/office/drawing/2014/main" id="{C5D9C68D-D61E-A5CD-B332-7CE2D78265C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9454131"/>
                  </p:ext>
                </p:extLst>
              </p:nvPr>
            </p:nvGraphicFramePr>
            <p:xfrm>
              <a:off x="257175" y="1273175"/>
              <a:ext cx="2101850" cy="32686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4" imgW="2267054" imgH="3528069" progId="Prism10.Document">
                      <p:embed/>
                    </p:oleObj>
                  </mc:Choice>
                  <mc:Fallback>
                    <p:oleObj name="Prism 10" r:id="rId4" imgW="2267054" imgH="3528069" progId="Prism10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57175" y="1273175"/>
                            <a:ext cx="2101850" cy="326866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B6F1919D-B825-F608-CE11-1F98CE20843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99748185"/>
                </p:ext>
              </p:extLst>
            </p:nvPr>
          </p:nvGraphicFramePr>
          <p:xfrm>
            <a:off x="4427916" y="1272602"/>
            <a:ext cx="1965424" cy="332177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053494" imgH="3471525" progId="Prism10.Document">
                    <p:embed/>
                  </p:oleObj>
                </mc:Choice>
                <mc:Fallback>
                  <p:oleObj name="Prism 10" r:id="rId6" imgW="2053494" imgH="3471525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427916" y="1272602"/>
                          <a:ext cx="1965424" cy="332177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148696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2">
            <a:extLst>
              <a:ext uri="{FF2B5EF4-FFF2-40B4-BE49-F238E27FC236}">
                <a16:creationId xmlns:a16="http://schemas.microsoft.com/office/drawing/2014/main" id="{7EF29644-4A6F-AEE2-4BB9-3E7228AE147E}"/>
              </a:ext>
            </a:extLst>
          </p:cNvPr>
          <p:cNvSpPr txBox="1"/>
          <p:nvPr/>
        </p:nvSpPr>
        <p:spPr>
          <a:xfrm>
            <a:off x="76200" y="4615180"/>
            <a:ext cx="6705600" cy="6756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rine albumin and urine creatinine quantification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 performed urine albumin (a) and urine creatinine (b) measurements in 6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phs1</a:t>
            </a:r>
            <a:r>
              <a:rPr lang="en-US" sz="1200" i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-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ol and 6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phs1</a:t>
            </a:r>
            <a:r>
              <a:rPr lang="en-US" sz="1200" i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at P0-P1. Two-tailed Mann-Whitney test for albumin P &lt; 0.01 and creatinine P &lt; 0.01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C861185-BE8B-ECB2-83E8-9032E53429D5}"/>
              </a:ext>
            </a:extLst>
          </p:cNvPr>
          <p:cNvGrpSpPr/>
          <p:nvPr/>
        </p:nvGrpSpPr>
        <p:grpSpPr>
          <a:xfrm>
            <a:off x="1329860" y="929747"/>
            <a:ext cx="4198280" cy="3502660"/>
            <a:chOff x="1329860" y="929747"/>
            <a:chExt cx="4198280" cy="3502660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C2CBE826-493F-558C-1DB5-AFFB019C7C43}"/>
                </a:ext>
              </a:extLst>
            </p:cNvPr>
            <p:cNvGrpSpPr/>
            <p:nvPr/>
          </p:nvGrpSpPr>
          <p:grpSpPr>
            <a:xfrm>
              <a:off x="1329860" y="929747"/>
              <a:ext cx="2484382" cy="400111"/>
              <a:chOff x="1403350" y="929748"/>
              <a:chExt cx="2484382" cy="400111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B532B21-4C04-5E9F-59B4-18494BC3CF2D}"/>
                  </a:ext>
                </a:extLst>
              </p:cNvPr>
              <p:cNvSpPr txBox="1"/>
              <p:nvPr/>
            </p:nvSpPr>
            <p:spPr>
              <a:xfrm>
                <a:off x="1403350" y="929749"/>
                <a:ext cx="2857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702F2FC-3A59-8C47-6035-1A18BCFA626F}"/>
                  </a:ext>
                </a:extLst>
              </p:cNvPr>
              <p:cNvSpPr txBox="1"/>
              <p:nvPr/>
            </p:nvSpPr>
            <p:spPr>
              <a:xfrm>
                <a:off x="3601982" y="929748"/>
                <a:ext cx="2857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A2C9B7C9-CD84-5DC9-23D0-28F7F98669F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18011632"/>
                </p:ext>
              </p:extLst>
            </p:nvPr>
          </p:nvGraphicFramePr>
          <p:xfrm>
            <a:off x="1403350" y="929748"/>
            <a:ext cx="1916169" cy="3502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112916" imgH="3861932" progId="Prism10.Document">
                    <p:embed/>
                  </p:oleObj>
                </mc:Choice>
                <mc:Fallback>
                  <p:oleObj name="Prism 10" r:id="rId2" imgW="2112916" imgH="3861932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403350" y="929748"/>
                          <a:ext cx="1916169" cy="3502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C9D65735-B4C7-601B-5D4F-C019EEACCD7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77719940"/>
                </p:ext>
              </p:extLst>
            </p:nvPr>
          </p:nvGraphicFramePr>
          <p:xfrm>
            <a:off x="3683954" y="929747"/>
            <a:ext cx="1844186" cy="35026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2033686" imgH="3861932" progId="Prism10.Document">
                    <p:embed/>
                  </p:oleObj>
                </mc:Choice>
                <mc:Fallback>
                  <p:oleObj name="Prism 10" r:id="rId4" imgW="2033686" imgH="3861932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683954" y="929747"/>
                          <a:ext cx="1844186" cy="35026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035304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49</TotalTime>
  <Words>279</Words>
  <Application>Microsoft Office PowerPoint</Application>
  <PresentationFormat>A4 Paper (210x297 mm)</PresentationFormat>
  <Paragraphs>2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arg_poster_ASN_2022</dc:title>
  <dc:creator>Saida, Ken</dc:creator>
  <cp:lastModifiedBy>Yousef, Kirollos</cp:lastModifiedBy>
  <cp:revision>163</cp:revision>
  <cp:lastPrinted>2023-04-03T18:42:01Z</cp:lastPrinted>
  <dcterms:created xsi:type="dcterms:W3CDTF">2022-10-24T16:34:35Z</dcterms:created>
  <dcterms:modified xsi:type="dcterms:W3CDTF">2024-06-07T15:50:47Z</dcterms:modified>
</cp:coreProperties>
</file>